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6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66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6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38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96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3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63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463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6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03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2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248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1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xmlns="" id="{6AC60252-966B-4855-AD63-9DA2108AFC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5645463"/>
              </p:ext>
            </p:extLst>
          </p:nvPr>
        </p:nvGraphicFramePr>
        <p:xfrm>
          <a:off x="838201" y="990600"/>
          <a:ext cx="8027796" cy="1928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979796">
                  <a:extLst>
                    <a:ext uri="{9D8B030D-6E8A-4147-A177-3AD203B41FA5}">
                      <a16:colId xmlns:a16="http://schemas.microsoft.com/office/drawing/2014/main" xmlns="" val="3785002835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xmlns="" val="3139265863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xmlns="" val="3357147869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xmlns="" val="3927804182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xmlns="" val="386599454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364640124"/>
                    </a:ext>
                  </a:extLst>
                </a:gridCol>
                <a:gridCol w="612000">
                  <a:extLst>
                    <a:ext uri="{9D8B030D-6E8A-4147-A177-3AD203B41FA5}">
                      <a16:colId xmlns:a16="http://schemas.microsoft.com/office/drawing/2014/main" xmlns="" val="3737422257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xmlns="" val="202568294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sz="1000" b="1" dirty="0"/>
                        <a:t>Whole-body composition</a:t>
                      </a:r>
                    </a:p>
                  </a:txBody>
                  <a:tcPr marL="62162" marR="62162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LS-0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LS-In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HS-0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r>
                        <a:rPr lang="fr-FR" sz="1000" b="1" dirty="0"/>
                        <a:t>HS-In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fr-FR" sz="1000" b="1" i="1" dirty="0"/>
                        <a:t>P</a:t>
                      </a:r>
                      <a:r>
                        <a:rPr lang="fr-FR" sz="1000" b="1" dirty="0"/>
                        <a:t> values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 sz="12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836815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US" sz="1000" i="1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2162" marR="62162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CHO/</a:t>
                      </a:r>
                    </a:p>
                    <a:p>
                      <a:r>
                        <a:rPr lang="fr-FR" sz="1000" b="1" dirty="0"/>
                        <a:t>Protein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Inulin 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000" b="1" dirty="0"/>
                        <a:t>Interaction</a:t>
                      </a:r>
                      <a:endParaRPr lang="en-US" sz="1000" b="1" dirty="0"/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91294719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100" noProof="0" dirty="0"/>
                        <a:t>Dry matter (DM), %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32.78 ± 0.15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33.33 ± 1.16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33.07 ± 0.65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33.13 ± 0.38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100" dirty="0"/>
                        <a:t>NS 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100" dirty="0"/>
                        <a:t>NS 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fr-FR" sz="1100" dirty="0"/>
                        <a:t>NS 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734144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fr-FR" sz="1100" dirty="0"/>
                        <a:t>Ash, % DM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6.07 ± 0.14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5.59 ± 0.13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5.73 ± 0.81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5.52 ± 0.48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388767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rude Protein, % DM</a:t>
                      </a:r>
                      <a:endParaRPr lang="en-US" sz="1100" b="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9.09 ± 0.41 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7.47 ± 0.50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8.15 ± 1.73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7.80 ± 0.55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335775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rude Lipids, % DM</a:t>
                      </a:r>
                      <a:endParaRPr lang="en-US" sz="1100" b="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4.93 ± 0.84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6.19 ± 0.29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5.42 ± 1.91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45.70 ± 1.00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466545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ross energy, kJ/g of DM</a:t>
                      </a:r>
                      <a:endParaRPr lang="en-US" sz="1100" b="0" dirty="0">
                        <a:effectLst/>
                        <a:latin typeface="+mn-lt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29.39 ± 0.41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29.85 ± 0.10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29.86 ± 0.55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29.73 ± 0.29</a:t>
                      </a:r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100" dirty="0"/>
                        <a:t>NS</a:t>
                      </a:r>
                      <a:endParaRPr lang="en-US" sz="1100" dirty="0"/>
                    </a:p>
                  </a:txBody>
                  <a:tcPr marL="90000" marR="90000" marT="45000" marB="4500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290275618"/>
                  </a:ext>
                </a:extLst>
              </a:tr>
            </a:tbl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F8C8097B-3D80-465C-8D13-4CB090E712DE}"/>
              </a:ext>
            </a:extLst>
          </p:cNvPr>
          <p:cNvSpPr txBox="1"/>
          <p:nvPr/>
        </p:nvSpPr>
        <p:spPr>
          <a:xfrm>
            <a:off x="838201" y="279225"/>
            <a:ext cx="82295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4. Table S4: </a:t>
            </a:r>
            <a:r>
              <a:rPr lang="en-US" sz="1200" dirty="0"/>
              <a:t>Whole-body composition of rainbow trout fed 100% plant-based diet with high or low levels of dietary carbohydrates and with or without 2% inulin during 12 weeks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219264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0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eta Decipolo</dc:creator>
  <cp:lastModifiedBy>Antonieta Decipolo</cp:lastModifiedBy>
  <cp:revision>2</cp:revision>
  <dcterms:created xsi:type="dcterms:W3CDTF">2023-10-23T00:05:00Z</dcterms:created>
  <dcterms:modified xsi:type="dcterms:W3CDTF">2023-10-23T00:07:09Z</dcterms:modified>
</cp:coreProperties>
</file>